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23964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022080" y="160452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45720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23964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022080" y="3682080"/>
            <a:ext cx="26496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457200" y="273600"/>
            <a:ext cx="8229240" cy="5307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3600"/>
            <a:ext cx="8229240" cy="114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3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3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934320" cy="502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10280" cy="508320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10280" cy="5081760"/>
          </a:xfrm>
          <a:prstGeom prst="rect">
            <a:avLst/>
          </a:prstGeom>
          <a:ln w="0">
            <a:noFill/>
          </a:ln>
        </p:spPr>
      </p:pic>
      <p:sp>
        <p:nvSpPr>
          <p:cNvPr id="57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934320" cy="5027760"/>
          </a:xfrm>
          <a:prstGeom prst="rect">
            <a:avLst/>
          </a:prstGeom>
          <a:ln w="0">
            <a:noFill/>
          </a:ln>
        </p:spPr>
      </p:pic>
      <p:sp>
        <p:nvSpPr>
          <p:cNvPr id="59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ve Lives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934320" cy="502776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ve Lives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858000" cy="497196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ve Lives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858000" cy="4971960"/>
          </a:xfrm>
          <a:prstGeom prst="rect">
            <a:avLst/>
          </a:prstGeom>
          <a:ln w="0">
            <a:noFill/>
          </a:ln>
        </p:spPr>
      </p:pic>
      <p:sp>
        <p:nvSpPr>
          <p:cNvPr id="65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ve Lives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858000" cy="497196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ve Lives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858000" cy="497196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ve Lives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858000" cy="4971960"/>
          </a:xfrm>
          <a:prstGeom prst="rect">
            <a:avLst/>
          </a:prstGeom>
          <a:ln w="0">
            <a:noFill/>
          </a:ln>
        </p:spPr>
      </p:pic>
      <p:sp>
        <p:nvSpPr>
          <p:cNvPr id="71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ctive Lives Contr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10280" cy="5083200"/>
          </a:xfrm>
          <a:prstGeom prst="rect">
            <a:avLst/>
          </a:prstGeom>
          <a:ln w="0">
            <a:noFill/>
          </a:ln>
        </p:spPr>
      </p:pic>
      <p:sp>
        <p:nvSpPr>
          <p:cNvPr id="40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10280" cy="50832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86600" cy="51386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6934320" cy="5027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86600" cy="513864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86600" cy="51372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10280" cy="50832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gradFill rotWithShape="0">
          <a:gsLst>
            <a:gs pos="0">
              <a:srgbClr val="0000ff"/>
            </a:gs>
            <a:gs pos="100000">
              <a:srgbClr val="bbe0e3"/>
            </a:gs>
          </a:gsLst>
          <a:lin ang="5400000"/>
        </a:gra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914400" y="685800"/>
            <a:ext cx="7010280" cy="508320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914400" y="6172200"/>
            <a:ext cx="701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QSN Interven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5T05:03:22Z</dcterms:created>
  <dc:creator/>
  <dc:description/>
  <dc:language>en-US</dc:language>
  <cp:lastModifiedBy>BG Danaher</cp:lastModifiedBy>
  <dcterms:modified xsi:type="dcterms:W3CDTF">2008-05-26T23:55:32Z</dcterms:modified>
  <cp:revision>6</cp:revision>
  <dc:subject/>
  <dc:title>Slide 1</dc:title>
</cp:coreProperties>
</file>